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852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892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679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573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626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483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238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130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814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993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776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786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F43D3-B96D-401C-8AF4-AF16618C3F67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A47D9-A950-4DF8-8ADF-346CF517A7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451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95DCAC62-255B-0111-2886-4CDFFF3DB0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39663" y="4207802"/>
            <a:ext cx="3359578" cy="1801018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A6C217BA-8C20-824B-85BF-4C48B0BE68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12802" y="2272472"/>
            <a:ext cx="3359578" cy="1806178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C0859909-BE6F-9AD7-53DA-0AAFA189E9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65545" y="353733"/>
            <a:ext cx="3306836" cy="179365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478A78ED-A10C-8066-A262-0E2D2AEFD852}"/>
              </a:ext>
            </a:extLst>
          </p:cNvPr>
          <p:cNvSpPr txBox="1"/>
          <p:nvPr/>
        </p:nvSpPr>
        <p:spPr>
          <a:xfrm>
            <a:off x="3826643" y="258792"/>
            <a:ext cx="35615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800" b="1" dirty="0"/>
              <a:t>A</a:t>
            </a:r>
            <a:endParaRPr lang="ko-KR" altLang="en-US" sz="2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81C5B6B-ABC7-E036-EBA5-C50B6727573A}"/>
              </a:ext>
            </a:extLst>
          </p:cNvPr>
          <p:cNvSpPr txBox="1"/>
          <p:nvPr/>
        </p:nvSpPr>
        <p:spPr>
          <a:xfrm>
            <a:off x="3809391" y="2162622"/>
            <a:ext cx="35615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800" b="1" dirty="0"/>
              <a:t>B</a:t>
            </a:r>
            <a:endParaRPr lang="ko-KR" altLang="en-US" sz="2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A67F61E-9284-0017-9D42-B705DBB0AF40}"/>
              </a:ext>
            </a:extLst>
          </p:cNvPr>
          <p:cNvSpPr txBox="1"/>
          <p:nvPr/>
        </p:nvSpPr>
        <p:spPr>
          <a:xfrm>
            <a:off x="3813453" y="4132809"/>
            <a:ext cx="35615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800" b="1" dirty="0"/>
              <a:t>C</a:t>
            </a:r>
            <a:endParaRPr lang="ko-KR" altLang="en-US" sz="2800" dirty="0"/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F6D6639A-EDE9-4EA8-18E9-6D5DB3B0624E}"/>
              </a:ext>
            </a:extLst>
          </p:cNvPr>
          <p:cNvSpPr/>
          <p:nvPr/>
        </p:nvSpPr>
        <p:spPr>
          <a:xfrm>
            <a:off x="4819538" y="2427398"/>
            <a:ext cx="1095172" cy="2562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65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VSE + anethole</a:t>
            </a:r>
            <a:endParaRPr lang="en-US" sz="1065" b="1" dirty="0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00C2C95B-E22C-8B15-F34C-57897FBA5F00}"/>
              </a:ext>
            </a:extLst>
          </p:cNvPr>
          <p:cNvSpPr/>
          <p:nvPr/>
        </p:nvSpPr>
        <p:spPr>
          <a:xfrm>
            <a:off x="5100359" y="465868"/>
            <a:ext cx="458780" cy="2562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65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VSE</a:t>
            </a:r>
            <a:endParaRPr lang="en-US" sz="1065" b="1" dirty="0"/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DB80D84A-483E-981D-952B-9A8B1312A852}"/>
              </a:ext>
            </a:extLst>
          </p:cNvPr>
          <p:cNvSpPr/>
          <p:nvPr/>
        </p:nvSpPr>
        <p:spPr>
          <a:xfrm>
            <a:off x="5020714" y="4299816"/>
            <a:ext cx="692818" cy="2562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65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ethole</a:t>
            </a:r>
            <a:endParaRPr lang="en-US" sz="1065" b="1" dirty="0"/>
          </a:p>
        </p:txBody>
      </p:sp>
      <p:sp>
        <p:nvSpPr>
          <p:cNvPr id="13" name="Arrow: Down 2">
            <a:extLst>
              <a:ext uri="{FF2B5EF4-FFF2-40B4-BE49-F238E27FC236}">
                <a16:creationId xmlns:a16="http://schemas.microsoft.com/office/drawing/2014/main" id="{B7F0D800-0A58-4BB0-D236-73C3E3C3F683}"/>
              </a:ext>
            </a:extLst>
          </p:cNvPr>
          <p:cNvSpPr/>
          <p:nvPr/>
        </p:nvSpPr>
        <p:spPr>
          <a:xfrm>
            <a:off x="6198788" y="959647"/>
            <a:ext cx="91200" cy="10763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80" dirty="0"/>
          </a:p>
        </p:txBody>
      </p:sp>
      <p:sp>
        <p:nvSpPr>
          <p:cNvPr id="18" name="Arrow: Down 2">
            <a:extLst>
              <a:ext uri="{FF2B5EF4-FFF2-40B4-BE49-F238E27FC236}">
                <a16:creationId xmlns:a16="http://schemas.microsoft.com/office/drawing/2014/main" id="{DB2E8C01-CAE3-6FF1-C784-D8B9702EC4C2}"/>
              </a:ext>
            </a:extLst>
          </p:cNvPr>
          <p:cNvSpPr/>
          <p:nvPr/>
        </p:nvSpPr>
        <p:spPr>
          <a:xfrm>
            <a:off x="6190162" y="4257567"/>
            <a:ext cx="91200" cy="10763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80"/>
          </a:p>
        </p:txBody>
      </p:sp>
      <p:sp>
        <p:nvSpPr>
          <p:cNvPr id="19" name="Arrow: Down 2">
            <a:extLst>
              <a:ext uri="{FF2B5EF4-FFF2-40B4-BE49-F238E27FC236}">
                <a16:creationId xmlns:a16="http://schemas.microsoft.com/office/drawing/2014/main" id="{CC819D5D-F4F6-95E0-2D4E-A989879795CE}"/>
              </a:ext>
            </a:extLst>
          </p:cNvPr>
          <p:cNvSpPr/>
          <p:nvPr/>
        </p:nvSpPr>
        <p:spPr>
          <a:xfrm>
            <a:off x="6186526" y="2238335"/>
            <a:ext cx="91200" cy="107638"/>
          </a:xfrm>
          <a:prstGeom prst="down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80"/>
          </a:p>
        </p:txBody>
      </p:sp>
      <p:pic>
        <p:nvPicPr>
          <p:cNvPr id="24" name="Picture 389" descr="trans-Anethole 99 4180-23-8">
            <a:extLst>
              <a:ext uri="{FF2B5EF4-FFF2-40B4-BE49-F238E27FC236}">
                <a16:creationId xmlns:a16="http://schemas.microsoft.com/office/drawing/2014/main" id="{134D2C0F-8E55-2CE6-AA85-15B855DFB6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10129" y="4460617"/>
            <a:ext cx="627135" cy="2069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41AAC56-F244-8EE0-6479-3DF258116425}"/>
              </a:ext>
            </a:extLst>
          </p:cNvPr>
          <p:cNvSpPr txBox="1"/>
          <p:nvPr/>
        </p:nvSpPr>
        <p:spPr>
          <a:xfrm>
            <a:off x="6216038" y="4667510"/>
            <a:ext cx="1017463" cy="2015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10" b="1" dirty="0">
                <a:latin typeface="Arial" panose="020B0604020202020204" pitchFamily="34" charset="0"/>
                <a:cs typeface="Arial" panose="020B0604020202020204" pitchFamily="34" charset="0"/>
              </a:rPr>
              <a:t>anethole standard</a:t>
            </a:r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FE7432F3-B954-43FA-9712-D882DA2A24A0}"/>
              </a:ext>
            </a:extLst>
          </p:cNvPr>
          <p:cNvSpPr/>
          <p:nvPr/>
        </p:nvSpPr>
        <p:spPr>
          <a:xfrm>
            <a:off x="1158714" y="5985197"/>
            <a:ext cx="10302829" cy="6767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2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4. Identification of the ‘anethole peak’ by gas chromatography-flame ionization detection (GC-FID). To confirm the identity of the ‘anethole peak’ marked with a red arrow in FVSE (A), 100,000 ppm of standard </a:t>
            </a:r>
            <a:r>
              <a:rPr lang="en-US" altLang="ko-KR" sz="1200" i="1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rans</a:t>
            </a:r>
            <a:r>
              <a:rPr lang="en-US" altLang="ko-KR" sz="1200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-anethole was added to the FVSE (B) or used as a standard alone (C), and subjected to GC-FID analysis (Agilent 8890, Agilent Technologies, Santa Clara, CA, USA)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6DF1497-0A01-4F55-BC3C-9491DDCBC2AA}"/>
              </a:ext>
            </a:extLst>
          </p:cNvPr>
          <p:cNvSpPr txBox="1"/>
          <p:nvPr/>
        </p:nvSpPr>
        <p:spPr>
          <a:xfrm>
            <a:off x="6096000" y="730909"/>
            <a:ext cx="1017463" cy="2015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10" b="1" dirty="0">
                <a:latin typeface="Arial" panose="020B0604020202020204" pitchFamily="34" charset="0"/>
                <a:cs typeface="Arial" panose="020B0604020202020204" pitchFamily="34" charset="0"/>
              </a:rPr>
              <a:t>‘anethole peak’</a:t>
            </a:r>
          </a:p>
        </p:txBody>
      </p:sp>
    </p:spTree>
    <p:extLst>
      <p:ext uri="{BB962C8B-B14F-4D97-AF65-F5344CB8AC3E}">
        <p14:creationId xmlns:p14="http://schemas.microsoft.com/office/powerpoint/2010/main" val="1784543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94</Words>
  <Application>Microsoft Office PowerPoint</Application>
  <PresentationFormat>와이드스크린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oonIS</cp:lastModifiedBy>
  <cp:revision>10</cp:revision>
  <dcterms:created xsi:type="dcterms:W3CDTF">2024-09-13T03:11:34Z</dcterms:created>
  <dcterms:modified xsi:type="dcterms:W3CDTF">2024-09-25T02:10:45Z</dcterms:modified>
</cp:coreProperties>
</file>